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1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4F4F5D-8814-4A59-9B5F-EA6AC3457E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AEA64A6-3D0E-4CDF-B750-BFEA9A7557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78ABC2-D1CE-4575-A1CE-E366C71D0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4329A1-883C-4B8F-89F4-FFF8CDFCE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FC75AE-B623-4A38-92F2-33998923F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01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B8031C-0D2D-4A1D-8DF8-108702F79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94C812-555C-401F-8AF4-EFFED73C1D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F91A3D-C106-4FFB-8C80-34454777D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8008F8-9315-4963-BEC5-344A10979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6B3D0B-1B9D-4F77-92CE-6DBEDA6B1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2233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85774EE-B2D8-4342-B64D-0D23FE8C60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4583C2-69FC-497D-9CBA-5DA08F4B36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71E288-6113-47B5-B522-AA2788AC6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CBD575-9E7D-40AE-BA15-7BB4DCA6C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617F34-3170-420D-AE64-63D8BEB04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985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DEF794-1EB6-4D7C-8A10-C37B58E003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9A7FA3-2F7D-4323-AE7C-13AD57A2D8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E3E4FC-9882-454F-8267-802775F3A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DF957D-E3C5-4FF6-A49B-C0CEAA5D3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8B0E8F-99CB-4779-BEFC-74D02649E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365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A748D5-77E9-4F05-BB13-E44056940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272A56-FFB8-412C-A037-DB504D8BA3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5B1F21-B1E8-4CCE-AFC7-2DA716FCC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257F77-9147-4986-B6D8-9D638C5CF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2DA4D4-6140-4B99-A838-2553F4C40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413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939055-54C4-49E8-B958-E1E912DCDF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90F0A33-ED43-4AC1-8959-10A7C0D57F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3F80938-5FEA-473F-9791-E8C2D27E82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1620AF-6A49-492F-B2A6-73327F4DD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F75B1A-D686-407E-BBE3-C6CA3A29C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FA024DE-8F72-48C3-B94E-F14B2074A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4790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9285D8-30A8-42AC-AF5A-9E10635B7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97EC2E-CB9F-4331-8328-2B527B7303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89BFCD-1C25-4380-8D34-414CC3D4BE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E1BF14A-8FBF-4365-8F32-CB22E82DD5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41606AB-D6D1-400C-885F-6E79E0C9C3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23E8B29-3242-4E87-870D-991256D91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0DFCC0F-837D-4920-BD18-E9C7DCB28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925638-15F4-4D44-AA4B-2CFE69C28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120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AD0550-AB26-4A62-9FF4-CF4A99F1D4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419100F-5269-4C31-8A2F-1B0988E60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21346B0-D69D-4C44-8932-829CB1A6D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2D10307-562B-4D9A-87B9-36CF22445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9435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F5E1776-4ECE-4BE1-9703-E6E5422C6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6B1E5D-B181-4103-8875-3C483FD59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CDA19FE-FAB0-491D-B175-7F08E59C9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0184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9A692D-D5B1-438C-BF84-96DE5C9DD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E8F493C-0F99-4E20-B58C-031B0BA303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BD3DC4B-6A0D-43EA-A4F5-03789B7FB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E797B9F-479C-46F2-A5AE-6B759F86B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8677E4-5E25-4034-8451-4A09771B3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62E85B2-8141-4779-9AA5-9BBB276E6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8587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E18C3B-E32C-43B2-AEF2-77B93EA71A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C38ABBA-D170-4B50-A0DE-674C34581D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0F620A-B895-4026-8A84-2B6537D4A7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1A3EB4-B2B2-41F7-9CB3-FE7D936A9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9072123-B02F-49AC-A647-37904FB7C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CDA0B8-8F18-4D1D-BE3B-E725B2ABB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254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6CBAA3C-D406-46FF-B0F7-D532393C4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D538B4-2109-467E-9F45-E2D3942487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A63035-929A-4CE5-B9A6-696D47A1AF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DF1E6-F19D-4B1F-B1F2-434AA7B90655}" type="datetimeFigureOut">
              <a:rPr lang="zh-CN" altLang="en-US" smtClean="0"/>
              <a:t>2020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1FF982-5079-4A9C-95AC-B0C5536FA2A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956A95-3901-4A89-9871-B28CBF9E2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7C03D-3164-4DE6-AB21-484D71DC50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914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"/><Relationship Id="rId16" Type="http://schemas.openxmlformats.org/officeDocument/2006/relationships/image" Target="../media/image15.tif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tiff"/><Relationship Id="rId24" Type="http://schemas.openxmlformats.org/officeDocument/2006/relationships/image" Target="../media/image23.tif"/><Relationship Id="rId5" Type="http://schemas.openxmlformats.org/officeDocument/2006/relationships/image" Target="../media/image4.tif"/><Relationship Id="rId15" Type="http://schemas.openxmlformats.org/officeDocument/2006/relationships/image" Target="../media/image14.tiff"/><Relationship Id="rId23" Type="http://schemas.openxmlformats.org/officeDocument/2006/relationships/image" Target="../media/image22.tif"/><Relationship Id="rId10" Type="http://schemas.openxmlformats.org/officeDocument/2006/relationships/image" Target="../media/image9.tiff"/><Relationship Id="rId19" Type="http://schemas.openxmlformats.org/officeDocument/2006/relationships/image" Target="../media/image18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f"/><Relationship Id="rId22" Type="http://schemas.openxmlformats.org/officeDocument/2006/relationships/image" Target="../media/image21.ti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5.tiff"/><Relationship Id="rId18" Type="http://schemas.openxmlformats.org/officeDocument/2006/relationships/image" Target="../media/image40.tiff"/><Relationship Id="rId26" Type="http://schemas.openxmlformats.org/officeDocument/2006/relationships/image" Target="../media/image48.tiff"/><Relationship Id="rId39" Type="http://schemas.openxmlformats.org/officeDocument/2006/relationships/image" Target="../media/image61.tiff"/><Relationship Id="rId21" Type="http://schemas.openxmlformats.org/officeDocument/2006/relationships/image" Target="../media/image43.tiff"/><Relationship Id="rId34" Type="http://schemas.openxmlformats.org/officeDocument/2006/relationships/image" Target="../media/image56.tiff"/><Relationship Id="rId42" Type="http://schemas.openxmlformats.org/officeDocument/2006/relationships/image" Target="../media/image64.tiff"/><Relationship Id="rId47" Type="http://schemas.openxmlformats.org/officeDocument/2006/relationships/image" Target="../media/image69.tiff"/><Relationship Id="rId50" Type="http://schemas.openxmlformats.org/officeDocument/2006/relationships/image" Target="../media/image72.tiff"/><Relationship Id="rId55" Type="http://schemas.openxmlformats.org/officeDocument/2006/relationships/image" Target="../media/image77.tiff"/><Relationship Id="rId7" Type="http://schemas.openxmlformats.org/officeDocument/2006/relationships/image" Target="../media/image29.tiff"/><Relationship Id="rId2" Type="http://schemas.openxmlformats.org/officeDocument/2006/relationships/image" Target="../media/image24.tiff"/><Relationship Id="rId16" Type="http://schemas.openxmlformats.org/officeDocument/2006/relationships/image" Target="../media/image38.tiff"/><Relationship Id="rId29" Type="http://schemas.openxmlformats.org/officeDocument/2006/relationships/image" Target="../media/image51.tiff"/><Relationship Id="rId11" Type="http://schemas.openxmlformats.org/officeDocument/2006/relationships/image" Target="../media/image33.tiff"/><Relationship Id="rId24" Type="http://schemas.openxmlformats.org/officeDocument/2006/relationships/image" Target="../media/image46.tiff"/><Relationship Id="rId32" Type="http://schemas.openxmlformats.org/officeDocument/2006/relationships/image" Target="../media/image54.tiff"/><Relationship Id="rId37" Type="http://schemas.openxmlformats.org/officeDocument/2006/relationships/image" Target="../media/image59.tiff"/><Relationship Id="rId40" Type="http://schemas.openxmlformats.org/officeDocument/2006/relationships/image" Target="../media/image62.tiff"/><Relationship Id="rId45" Type="http://schemas.openxmlformats.org/officeDocument/2006/relationships/image" Target="../media/image67.tiff"/><Relationship Id="rId53" Type="http://schemas.openxmlformats.org/officeDocument/2006/relationships/image" Target="../media/image75.tiff"/><Relationship Id="rId58" Type="http://schemas.openxmlformats.org/officeDocument/2006/relationships/image" Target="../media/image80.tiff"/><Relationship Id="rId5" Type="http://schemas.openxmlformats.org/officeDocument/2006/relationships/image" Target="../media/image27.tiff"/><Relationship Id="rId61" Type="http://schemas.openxmlformats.org/officeDocument/2006/relationships/image" Target="../media/image83.tiff"/><Relationship Id="rId19" Type="http://schemas.openxmlformats.org/officeDocument/2006/relationships/image" Target="../media/image41.tiff"/><Relationship Id="rId14" Type="http://schemas.openxmlformats.org/officeDocument/2006/relationships/image" Target="../media/image36.tiff"/><Relationship Id="rId22" Type="http://schemas.openxmlformats.org/officeDocument/2006/relationships/image" Target="../media/image44.tiff"/><Relationship Id="rId27" Type="http://schemas.openxmlformats.org/officeDocument/2006/relationships/image" Target="../media/image49.tiff"/><Relationship Id="rId30" Type="http://schemas.openxmlformats.org/officeDocument/2006/relationships/image" Target="../media/image52.tiff"/><Relationship Id="rId35" Type="http://schemas.openxmlformats.org/officeDocument/2006/relationships/image" Target="../media/image57.tiff"/><Relationship Id="rId43" Type="http://schemas.openxmlformats.org/officeDocument/2006/relationships/image" Target="../media/image65.tiff"/><Relationship Id="rId48" Type="http://schemas.openxmlformats.org/officeDocument/2006/relationships/image" Target="../media/image70.tiff"/><Relationship Id="rId56" Type="http://schemas.openxmlformats.org/officeDocument/2006/relationships/image" Target="../media/image78.tiff"/><Relationship Id="rId8" Type="http://schemas.openxmlformats.org/officeDocument/2006/relationships/image" Target="../media/image30.tiff"/><Relationship Id="rId51" Type="http://schemas.openxmlformats.org/officeDocument/2006/relationships/image" Target="../media/image73.tiff"/><Relationship Id="rId3" Type="http://schemas.openxmlformats.org/officeDocument/2006/relationships/image" Target="../media/image25.tiff"/><Relationship Id="rId12" Type="http://schemas.openxmlformats.org/officeDocument/2006/relationships/image" Target="../media/image34.tiff"/><Relationship Id="rId17" Type="http://schemas.openxmlformats.org/officeDocument/2006/relationships/image" Target="../media/image39.tiff"/><Relationship Id="rId25" Type="http://schemas.openxmlformats.org/officeDocument/2006/relationships/image" Target="../media/image47.tiff"/><Relationship Id="rId33" Type="http://schemas.openxmlformats.org/officeDocument/2006/relationships/image" Target="../media/image55.tiff"/><Relationship Id="rId38" Type="http://schemas.openxmlformats.org/officeDocument/2006/relationships/image" Target="../media/image60.tiff"/><Relationship Id="rId46" Type="http://schemas.openxmlformats.org/officeDocument/2006/relationships/image" Target="../media/image68.tiff"/><Relationship Id="rId59" Type="http://schemas.openxmlformats.org/officeDocument/2006/relationships/image" Target="../media/image81.tiff"/><Relationship Id="rId20" Type="http://schemas.openxmlformats.org/officeDocument/2006/relationships/image" Target="../media/image42.tiff"/><Relationship Id="rId41" Type="http://schemas.openxmlformats.org/officeDocument/2006/relationships/image" Target="../media/image63.tiff"/><Relationship Id="rId54" Type="http://schemas.openxmlformats.org/officeDocument/2006/relationships/image" Target="../media/image7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15" Type="http://schemas.openxmlformats.org/officeDocument/2006/relationships/image" Target="../media/image37.tiff"/><Relationship Id="rId23" Type="http://schemas.openxmlformats.org/officeDocument/2006/relationships/image" Target="../media/image45.tiff"/><Relationship Id="rId28" Type="http://schemas.openxmlformats.org/officeDocument/2006/relationships/image" Target="../media/image50.tiff"/><Relationship Id="rId36" Type="http://schemas.openxmlformats.org/officeDocument/2006/relationships/image" Target="../media/image58.tiff"/><Relationship Id="rId49" Type="http://schemas.openxmlformats.org/officeDocument/2006/relationships/image" Target="../media/image71.tiff"/><Relationship Id="rId57" Type="http://schemas.openxmlformats.org/officeDocument/2006/relationships/image" Target="../media/image79.tiff"/><Relationship Id="rId10" Type="http://schemas.openxmlformats.org/officeDocument/2006/relationships/image" Target="../media/image32.tiff"/><Relationship Id="rId31" Type="http://schemas.openxmlformats.org/officeDocument/2006/relationships/image" Target="../media/image53.tiff"/><Relationship Id="rId44" Type="http://schemas.openxmlformats.org/officeDocument/2006/relationships/image" Target="../media/image66.tiff"/><Relationship Id="rId52" Type="http://schemas.openxmlformats.org/officeDocument/2006/relationships/image" Target="../media/image74.tiff"/><Relationship Id="rId60" Type="http://schemas.openxmlformats.org/officeDocument/2006/relationships/image" Target="../media/image82.tiff"/><Relationship Id="rId4" Type="http://schemas.openxmlformats.org/officeDocument/2006/relationships/image" Target="../media/image26.tiff"/><Relationship Id="rId9" Type="http://schemas.openxmlformats.org/officeDocument/2006/relationships/image" Target="../media/image3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文本框 95">
            <a:extLst>
              <a:ext uri="{FF2B5EF4-FFF2-40B4-BE49-F238E27FC236}">
                <a16:creationId xmlns:a16="http://schemas.microsoft.com/office/drawing/2014/main" id="{DA0774E1-B6A3-421E-AA55-1F6D5A40FD37}"/>
              </a:ext>
            </a:extLst>
          </p:cNvPr>
          <p:cNvSpPr txBox="1"/>
          <p:nvPr/>
        </p:nvSpPr>
        <p:spPr>
          <a:xfrm>
            <a:off x="-69673" y="-35693"/>
            <a:ext cx="1254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S1-A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3" name="组合 172">
            <a:extLst>
              <a:ext uri="{FF2B5EF4-FFF2-40B4-BE49-F238E27FC236}">
                <a16:creationId xmlns:a16="http://schemas.microsoft.com/office/drawing/2014/main" id="{5334038C-508F-4A68-B320-91BC6CD34060}"/>
              </a:ext>
            </a:extLst>
          </p:cNvPr>
          <p:cNvGrpSpPr/>
          <p:nvPr/>
        </p:nvGrpSpPr>
        <p:grpSpPr>
          <a:xfrm>
            <a:off x="3363988" y="1529885"/>
            <a:ext cx="2388546" cy="417211"/>
            <a:chOff x="415041" y="1472403"/>
            <a:chExt cx="2388546" cy="417211"/>
          </a:xfrm>
        </p:grpSpPr>
        <p:sp>
          <p:nvSpPr>
            <p:cNvPr id="174" name="文本框 173">
              <a:extLst>
                <a:ext uri="{FF2B5EF4-FFF2-40B4-BE49-F238E27FC236}">
                  <a16:creationId xmlns:a16="http://schemas.microsoft.com/office/drawing/2014/main" id="{A81B272E-221E-482C-AE01-E0B4DCBB983F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4B157268-6235-48D4-B189-47B7029AA8E3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grpSp>
        <p:nvGrpSpPr>
          <p:cNvPr id="176" name="组合 175">
            <a:extLst>
              <a:ext uri="{FF2B5EF4-FFF2-40B4-BE49-F238E27FC236}">
                <a16:creationId xmlns:a16="http://schemas.microsoft.com/office/drawing/2014/main" id="{E1D5F7F4-E79C-4FAE-AFF2-BE4020D0DC71}"/>
              </a:ext>
            </a:extLst>
          </p:cNvPr>
          <p:cNvGrpSpPr/>
          <p:nvPr/>
        </p:nvGrpSpPr>
        <p:grpSpPr>
          <a:xfrm>
            <a:off x="1980994" y="1485100"/>
            <a:ext cx="2388546" cy="417211"/>
            <a:chOff x="415041" y="1472403"/>
            <a:chExt cx="2388546" cy="417211"/>
          </a:xfrm>
        </p:grpSpPr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2B950C86-BA0E-4283-8FAA-7A549D06D2B4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DF86D142-BBBE-4F67-82B9-2A23BB8DD189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grpSp>
        <p:nvGrpSpPr>
          <p:cNvPr id="179" name="组合 178">
            <a:extLst>
              <a:ext uri="{FF2B5EF4-FFF2-40B4-BE49-F238E27FC236}">
                <a16:creationId xmlns:a16="http://schemas.microsoft.com/office/drawing/2014/main" id="{60651552-0FFD-4A3D-84D0-B418643E6738}"/>
              </a:ext>
            </a:extLst>
          </p:cNvPr>
          <p:cNvGrpSpPr/>
          <p:nvPr/>
        </p:nvGrpSpPr>
        <p:grpSpPr>
          <a:xfrm>
            <a:off x="416229" y="1482025"/>
            <a:ext cx="2388546" cy="417211"/>
            <a:chOff x="415041" y="1472403"/>
            <a:chExt cx="2388546" cy="417211"/>
          </a:xfrm>
        </p:grpSpPr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D3D220C4-C08F-466E-9298-F5C322A193B6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81" name="文本框 180">
              <a:extLst>
                <a:ext uri="{FF2B5EF4-FFF2-40B4-BE49-F238E27FC236}">
                  <a16:creationId xmlns:a16="http://schemas.microsoft.com/office/drawing/2014/main" id="{B7C9A6B6-A304-465F-A0EE-1E9049CD45D2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grpSp>
        <p:nvGrpSpPr>
          <p:cNvPr id="88" name="组合 87">
            <a:extLst>
              <a:ext uri="{FF2B5EF4-FFF2-40B4-BE49-F238E27FC236}">
                <a16:creationId xmlns:a16="http://schemas.microsoft.com/office/drawing/2014/main" id="{E6894028-41D9-4162-84FE-802CFF18941A}"/>
              </a:ext>
            </a:extLst>
          </p:cNvPr>
          <p:cNvGrpSpPr/>
          <p:nvPr/>
        </p:nvGrpSpPr>
        <p:grpSpPr>
          <a:xfrm>
            <a:off x="6341934" y="623035"/>
            <a:ext cx="5172755" cy="1106642"/>
            <a:chOff x="6307424" y="3764035"/>
            <a:chExt cx="4168403" cy="793102"/>
          </a:xfrm>
        </p:grpSpPr>
        <p:grpSp>
          <p:nvGrpSpPr>
            <p:cNvPr id="86" name="组合 85">
              <a:extLst>
                <a:ext uri="{FF2B5EF4-FFF2-40B4-BE49-F238E27FC236}">
                  <a16:creationId xmlns:a16="http://schemas.microsoft.com/office/drawing/2014/main" id="{DF0E7732-7046-46BF-9D14-DEBBC23327DF}"/>
                </a:ext>
              </a:extLst>
            </p:cNvPr>
            <p:cNvGrpSpPr/>
            <p:nvPr/>
          </p:nvGrpSpPr>
          <p:grpSpPr>
            <a:xfrm>
              <a:off x="6307424" y="3769967"/>
              <a:ext cx="1368000" cy="785199"/>
              <a:chOff x="6007608" y="4711826"/>
              <a:chExt cx="1368000" cy="785199"/>
            </a:xfrm>
          </p:grpSpPr>
          <p:pic>
            <p:nvPicPr>
              <p:cNvPr id="70" name="图片 69">
                <a:extLst>
                  <a:ext uri="{FF2B5EF4-FFF2-40B4-BE49-F238E27FC236}">
                    <a16:creationId xmlns:a16="http://schemas.microsoft.com/office/drawing/2014/main" id="{F50F859E-BAC9-4408-860F-897CAA6694D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07608" y="5119025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6" name="图片 75">
                <a:extLst>
                  <a:ext uri="{FF2B5EF4-FFF2-40B4-BE49-F238E27FC236}">
                    <a16:creationId xmlns:a16="http://schemas.microsoft.com/office/drawing/2014/main" id="{700DE503-61FC-4C0F-80C8-401FCDEA417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07608" y="4711826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ECDF0D92-37B9-4427-9F8E-2FDDCBF05E93}"/>
                </a:ext>
              </a:extLst>
            </p:cNvPr>
            <p:cNvGrpSpPr/>
            <p:nvPr/>
          </p:nvGrpSpPr>
          <p:grpSpPr>
            <a:xfrm>
              <a:off x="7705899" y="3764035"/>
              <a:ext cx="1368001" cy="782422"/>
              <a:chOff x="7593960" y="4546011"/>
              <a:chExt cx="1368001" cy="782422"/>
            </a:xfrm>
          </p:grpSpPr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F1F201FD-791A-45F0-A3E6-01064BA8178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93961" y="4950433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8" name="图片 77">
                <a:extLst>
                  <a:ext uri="{FF2B5EF4-FFF2-40B4-BE49-F238E27FC236}">
                    <a16:creationId xmlns:a16="http://schemas.microsoft.com/office/drawing/2014/main" id="{08D60E6E-8DF5-4923-AF91-40AE99A8955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93960" y="4546011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631C9B89-0B44-4E8B-A387-37639F802855}"/>
                </a:ext>
              </a:extLst>
            </p:cNvPr>
            <p:cNvGrpSpPr/>
            <p:nvPr/>
          </p:nvGrpSpPr>
          <p:grpSpPr>
            <a:xfrm>
              <a:off x="9107166" y="3771068"/>
              <a:ext cx="1368661" cy="786069"/>
              <a:chOff x="9070124" y="4693538"/>
              <a:chExt cx="1368661" cy="786069"/>
            </a:xfrm>
          </p:grpSpPr>
          <p:pic>
            <p:nvPicPr>
              <p:cNvPr id="74" name="图片 73">
                <a:extLst>
                  <a:ext uri="{FF2B5EF4-FFF2-40B4-BE49-F238E27FC236}">
                    <a16:creationId xmlns:a16="http://schemas.microsoft.com/office/drawing/2014/main" id="{36ACB292-E4C6-41B4-8C14-5440002B0FD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0124" y="510160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30D165B2-5C18-4D3D-9B8E-E6613668CF7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0785" y="4693538"/>
                <a:ext cx="1368000" cy="378000"/>
              </a:xfrm>
              <a:prstGeom prst="rect">
                <a:avLst/>
              </a:prstGeom>
            </p:spPr>
          </p:pic>
        </p:grpSp>
      </p:grpSp>
      <p:sp>
        <p:nvSpPr>
          <p:cNvPr id="89" name="文本框 88">
            <a:extLst>
              <a:ext uri="{FF2B5EF4-FFF2-40B4-BE49-F238E27FC236}">
                <a16:creationId xmlns:a16="http://schemas.microsoft.com/office/drawing/2014/main" id="{89E626FA-CB63-42C7-9D32-A4B749CC6C06}"/>
              </a:ext>
            </a:extLst>
          </p:cNvPr>
          <p:cNvSpPr txBox="1"/>
          <p:nvPr/>
        </p:nvSpPr>
        <p:spPr>
          <a:xfrm>
            <a:off x="5453452" y="837524"/>
            <a:ext cx="972119" cy="11595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P2</a:t>
            </a:r>
          </a:p>
          <a:p>
            <a:pPr algn="r"/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3A1DB637-4314-4A7A-B757-078E3F8DF513}"/>
              </a:ext>
            </a:extLst>
          </p:cNvPr>
          <p:cNvSpPr txBox="1"/>
          <p:nvPr/>
        </p:nvSpPr>
        <p:spPr>
          <a:xfrm>
            <a:off x="11489380" y="821955"/>
            <a:ext cx="885833" cy="11595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</a:t>
            </a:r>
          </a:p>
          <a:p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AD4EFDAE-4426-42A4-A92A-CE8204218F1C}"/>
              </a:ext>
            </a:extLst>
          </p:cNvPr>
          <p:cNvSpPr txBox="1"/>
          <p:nvPr/>
        </p:nvSpPr>
        <p:spPr>
          <a:xfrm>
            <a:off x="6260101" y="238970"/>
            <a:ext cx="19594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U-387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9" name="组合 98">
            <a:extLst>
              <a:ext uri="{FF2B5EF4-FFF2-40B4-BE49-F238E27FC236}">
                <a16:creationId xmlns:a16="http://schemas.microsoft.com/office/drawing/2014/main" id="{C5EB5C69-27E8-40C3-A9D9-3D22D67EA6BE}"/>
              </a:ext>
            </a:extLst>
          </p:cNvPr>
          <p:cNvGrpSpPr/>
          <p:nvPr/>
        </p:nvGrpSpPr>
        <p:grpSpPr>
          <a:xfrm>
            <a:off x="9526451" y="1663913"/>
            <a:ext cx="2838282" cy="497545"/>
            <a:chOff x="5842693" y="1543207"/>
            <a:chExt cx="2838282" cy="497545"/>
          </a:xfrm>
        </p:grpSpPr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D8F30B2B-F262-4D4F-9D89-57A9A3B79F2D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BA6C8539-5C2B-49EF-96AB-C00407B1620A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1AFF0E41-94C3-4C50-B93D-38F8DD744E53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EBACFC5F-8320-4217-BDF9-8B46557235F4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grpSp>
        <p:nvGrpSpPr>
          <p:cNvPr id="115" name="组合 114">
            <a:extLst>
              <a:ext uri="{FF2B5EF4-FFF2-40B4-BE49-F238E27FC236}">
                <a16:creationId xmlns:a16="http://schemas.microsoft.com/office/drawing/2014/main" id="{DBE9D39E-8EB5-4FDD-9F44-066F2B79350A}"/>
              </a:ext>
            </a:extLst>
          </p:cNvPr>
          <p:cNvGrpSpPr/>
          <p:nvPr/>
        </p:nvGrpSpPr>
        <p:grpSpPr>
          <a:xfrm>
            <a:off x="7833946" y="1631109"/>
            <a:ext cx="2838282" cy="497545"/>
            <a:chOff x="5842693" y="1543207"/>
            <a:chExt cx="2838282" cy="497545"/>
          </a:xfrm>
        </p:grpSpPr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AB6B6789-2236-460A-A348-8ED4D79E4C16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265E00E8-A67E-40DA-9F02-7B8C7229BCC1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0A9514B4-C0E0-4E1B-961E-FA3E068982E4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C48E880E-B650-42E6-9F77-4CC23A80FE05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EFA3731E-9008-4FD4-9DF9-359A544AB448}"/>
              </a:ext>
            </a:extLst>
          </p:cNvPr>
          <p:cNvGrpSpPr/>
          <p:nvPr/>
        </p:nvGrpSpPr>
        <p:grpSpPr>
          <a:xfrm>
            <a:off x="5943227" y="1633489"/>
            <a:ext cx="2838282" cy="497545"/>
            <a:chOff x="5842693" y="1543207"/>
            <a:chExt cx="2838282" cy="497545"/>
          </a:xfrm>
        </p:grpSpPr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5DF0323A-4703-48B1-907C-330877A26BD5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4CB27C2D-18CD-4B3B-9179-AF98E3EA740F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BDD46E92-6A5D-42AA-AB65-233613DA08EA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349528E9-DCB2-4858-932C-92F814DB7DD8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sp>
        <p:nvSpPr>
          <p:cNvPr id="40" name="文本框 39">
            <a:extLst>
              <a:ext uri="{FF2B5EF4-FFF2-40B4-BE49-F238E27FC236}">
                <a16:creationId xmlns:a16="http://schemas.microsoft.com/office/drawing/2014/main" id="{64CCDEC1-1F11-42F4-A70F-2C679130E7D4}"/>
              </a:ext>
            </a:extLst>
          </p:cNvPr>
          <p:cNvSpPr txBox="1"/>
          <p:nvPr/>
        </p:nvSpPr>
        <p:spPr>
          <a:xfrm>
            <a:off x="817217" y="285922"/>
            <a:ext cx="18877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U-387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DC83B01D-1226-4F9F-A679-A634E32140E6}"/>
              </a:ext>
            </a:extLst>
          </p:cNvPr>
          <p:cNvGrpSpPr/>
          <p:nvPr/>
        </p:nvGrpSpPr>
        <p:grpSpPr>
          <a:xfrm>
            <a:off x="885133" y="667000"/>
            <a:ext cx="1325223" cy="1042814"/>
            <a:chOff x="1024077" y="4825793"/>
            <a:chExt cx="1375512" cy="794566"/>
          </a:xfrm>
        </p:grpSpPr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3E54AF1C-918D-47D7-B1CB-7E6CC31C3F8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4077" y="5242359"/>
              <a:ext cx="1368000" cy="378000"/>
            </a:xfrm>
            <a:prstGeom prst="rect">
              <a:avLst/>
            </a:prstGeom>
          </p:spPr>
        </p:pic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2BC482DF-16F5-4295-8A84-2BBF8E2D322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1589" y="4825793"/>
              <a:ext cx="1368000" cy="378000"/>
            </a:xfrm>
            <a:prstGeom prst="rect">
              <a:avLst/>
            </a:prstGeom>
          </p:spPr>
        </p:pic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0A1B9B5A-D6DF-4913-90F1-C642AED0FA7C}"/>
              </a:ext>
            </a:extLst>
          </p:cNvPr>
          <p:cNvGrpSpPr/>
          <p:nvPr/>
        </p:nvGrpSpPr>
        <p:grpSpPr>
          <a:xfrm>
            <a:off x="2243420" y="674429"/>
            <a:ext cx="1367026" cy="1038151"/>
            <a:chOff x="2712585" y="4831457"/>
            <a:chExt cx="1368000" cy="791014"/>
          </a:xfrm>
        </p:grpSpPr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43271328-C858-45B3-9BFC-EB2BE14F4E6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2585" y="5244471"/>
              <a:ext cx="1368000" cy="378000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C7EDA758-6C6F-4BAD-893B-BCBDDB743C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2585" y="4831457"/>
              <a:ext cx="1368000" cy="378000"/>
            </a:xfrm>
            <a:prstGeom prst="rect">
              <a:avLst/>
            </a:prstGeom>
          </p:spPr>
        </p:pic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993B9F21-4BA3-4925-9373-3C082A898522}"/>
              </a:ext>
            </a:extLst>
          </p:cNvPr>
          <p:cNvGrpSpPr/>
          <p:nvPr/>
        </p:nvGrpSpPr>
        <p:grpSpPr>
          <a:xfrm>
            <a:off x="3643238" y="690274"/>
            <a:ext cx="1425335" cy="1031385"/>
            <a:chOff x="4116600" y="4825793"/>
            <a:chExt cx="1368000" cy="785858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F2A3089E-2EE4-41E1-A53C-13422499451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16600" y="5233651"/>
              <a:ext cx="1368000" cy="378000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6DB49305-C9A0-4B02-A28C-F1F568D391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16600" y="4825793"/>
              <a:ext cx="1368000" cy="378000"/>
            </a:xfrm>
            <a:prstGeom prst="rect">
              <a:avLst/>
            </a:prstGeom>
          </p:spPr>
        </p:pic>
      </p:grpSp>
      <p:sp>
        <p:nvSpPr>
          <p:cNvPr id="42" name="文本框 41">
            <a:extLst>
              <a:ext uri="{FF2B5EF4-FFF2-40B4-BE49-F238E27FC236}">
                <a16:creationId xmlns:a16="http://schemas.microsoft.com/office/drawing/2014/main" id="{B0485A9B-C038-443D-AED0-18DCD6AA7943}"/>
              </a:ext>
            </a:extLst>
          </p:cNvPr>
          <p:cNvSpPr txBox="1"/>
          <p:nvPr/>
        </p:nvSpPr>
        <p:spPr>
          <a:xfrm>
            <a:off x="-44287" y="867299"/>
            <a:ext cx="93657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P2</a:t>
            </a:r>
          </a:p>
          <a:p>
            <a:pPr algn="r"/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06431F1-7BA8-4DC0-BD2F-19E0ABA1F34A}"/>
              </a:ext>
            </a:extLst>
          </p:cNvPr>
          <p:cNvSpPr txBox="1"/>
          <p:nvPr/>
        </p:nvSpPr>
        <p:spPr>
          <a:xfrm>
            <a:off x="4976579" y="830407"/>
            <a:ext cx="853447" cy="848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</a:t>
            </a:r>
          </a:p>
          <a:p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02175FA7-0818-4295-8F9F-64ED159C93E1}"/>
              </a:ext>
            </a:extLst>
          </p:cNvPr>
          <p:cNvGrpSpPr/>
          <p:nvPr/>
        </p:nvGrpSpPr>
        <p:grpSpPr>
          <a:xfrm>
            <a:off x="489381" y="3687766"/>
            <a:ext cx="2388546" cy="417211"/>
            <a:chOff x="415041" y="1472403"/>
            <a:chExt cx="2388546" cy="417211"/>
          </a:xfrm>
        </p:grpSpPr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D29BEB3-E0BF-4D05-A7E3-B840AE89520A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0E3BC66-8AA4-4B6F-88EA-1A24EE170667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EEDC0EC3-5967-4A70-931A-AFD421A933A3}"/>
              </a:ext>
            </a:extLst>
          </p:cNvPr>
          <p:cNvGrpSpPr/>
          <p:nvPr/>
        </p:nvGrpSpPr>
        <p:grpSpPr>
          <a:xfrm>
            <a:off x="875532" y="2893539"/>
            <a:ext cx="1360571" cy="996322"/>
            <a:chOff x="935831" y="1615640"/>
            <a:chExt cx="1368000" cy="802342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A18553B7-B3F6-4838-AF77-E4494D79BA7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5831" y="2039982"/>
              <a:ext cx="1368000" cy="37800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505B93A2-797E-4D2A-9887-65CCDA43D5D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5831" y="1615640"/>
              <a:ext cx="1368000" cy="378000"/>
            </a:xfrm>
            <a:prstGeom prst="rect">
              <a:avLst/>
            </a:prstGeom>
          </p:spPr>
        </p:pic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8991AB87-1272-45EA-9897-37D0D0C2D8E5}"/>
              </a:ext>
            </a:extLst>
          </p:cNvPr>
          <p:cNvGrpSpPr/>
          <p:nvPr/>
        </p:nvGrpSpPr>
        <p:grpSpPr>
          <a:xfrm>
            <a:off x="2258622" y="2900973"/>
            <a:ext cx="1355167" cy="985508"/>
            <a:chOff x="2347236" y="1615640"/>
            <a:chExt cx="1368000" cy="793633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C378267-4CCD-4372-9BFE-9FBE7D82F12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7236" y="2031273"/>
              <a:ext cx="1368000" cy="378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0F0046F0-403B-4B7D-982D-59BD378ED80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7236" y="1615640"/>
              <a:ext cx="1368000" cy="378000"/>
            </a:xfrm>
            <a:prstGeom prst="rect">
              <a:avLst/>
            </a:prstGeom>
          </p:spPr>
        </p:pic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F5C48436-DA51-491A-991D-F2CE7644F492}"/>
              </a:ext>
            </a:extLst>
          </p:cNvPr>
          <p:cNvGrpSpPr/>
          <p:nvPr/>
        </p:nvGrpSpPr>
        <p:grpSpPr>
          <a:xfrm>
            <a:off x="3634673" y="2904354"/>
            <a:ext cx="1362641" cy="985508"/>
            <a:chOff x="3796122" y="1624349"/>
            <a:chExt cx="1368000" cy="793633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5A1A634-6FD5-4D6F-BFDC-462EF790C64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6122" y="2039982"/>
              <a:ext cx="1368000" cy="378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A84CC944-BF38-4C75-ACCE-3757414BCF0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6122" y="1624349"/>
              <a:ext cx="1368000" cy="378000"/>
            </a:xfrm>
            <a:prstGeom prst="rect">
              <a:avLst/>
            </a:prstGeom>
          </p:spPr>
        </p:pic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48B95CCB-38DE-497F-9F1D-A8C0889115B4}"/>
              </a:ext>
            </a:extLst>
          </p:cNvPr>
          <p:cNvSpPr txBox="1"/>
          <p:nvPr/>
        </p:nvSpPr>
        <p:spPr>
          <a:xfrm>
            <a:off x="875532" y="2559875"/>
            <a:ext cx="1876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3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039B51F-6DCE-4A83-89B9-377D16E94761}"/>
              </a:ext>
            </a:extLst>
          </p:cNvPr>
          <p:cNvSpPr txBox="1"/>
          <p:nvPr/>
        </p:nvSpPr>
        <p:spPr>
          <a:xfrm>
            <a:off x="16420" y="3071009"/>
            <a:ext cx="930769" cy="830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P2</a:t>
            </a:r>
          </a:p>
          <a:p>
            <a:pPr algn="r"/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405D16B-643F-4043-9BD1-53626FF6ADD9}"/>
              </a:ext>
            </a:extLst>
          </p:cNvPr>
          <p:cNvSpPr txBox="1"/>
          <p:nvPr/>
        </p:nvSpPr>
        <p:spPr>
          <a:xfrm>
            <a:off x="4878050" y="3034489"/>
            <a:ext cx="848152" cy="830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</a:t>
            </a:r>
          </a:p>
          <a:p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EED1DB4E-B76D-4388-B688-34E01E98C68C}"/>
              </a:ext>
            </a:extLst>
          </p:cNvPr>
          <p:cNvSpPr txBox="1"/>
          <p:nvPr/>
        </p:nvSpPr>
        <p:spPr>
          <a:xfrm>
            <a:off x="6293879" y="2531840"/>
            <a:ext cx="2090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3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ECB797EB-7AAB-40DB-B79F-C682C775676F}"/>
              </a:ext>
            </a:extLst>
          </p:cNvPr>
          <p:cNvSpPr txBox="1"/>
          <p:nvPr/>
        </p:nvSpPr>
        <p:spPr>
          <a:xfrm>
            <a:off x="11486712" y="3015353"/>
            <a:ext cx="945097" cy="11005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</a:t>
            </a:r>
          </a:p>
          <a:p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5CAEA25F-2FB8-42D2-A709-9989FAD4A0D7}"/>
              </a:ext>
            </a:extLst>
          </p:cNvPr>
          <p:cNvGrpSpPr/>
          <p:nvPr/>
        </p:nvGrpSpPr>
        <p:grpSpPr>
          <a:xfrm>
            <a:off x="6286228" y="2889705"/>
            <a:ext cx="5228464" cy="1047678"/>
            <a:chOff x="6316133" y="2588701"/>
            <a:chExt cx="4154441" cy="791039"/>
          </a:xfrm>
        </p:grpSpPr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17CB045E-5952-4E91-8193-DDAE3E977D62}"/>
                </a:ext>
              </a:extLst>
            </p:cNvPr>
            <p:cNvGrpSpPr/>
            <p:nvPr/>
          </p:nvGrpSpPr>
          <p:grpSpPr>
            <a:xfrm>
              <a:off x="6316133" y="2591749"/>
              <a:ext cx="1368000" cy="787991"/>
              <a:chOff x="5897142" y="2617114"/>
              <a:chExt cx="1368000" cy="787991"/>
            </a:xfrm>
          </p:grpSpPr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EA5B602D-03E5-4CF3-8AB8-AC8AD7DD82F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97142" y="3027105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772E66C0-3CC5-4977-8A1F-2760803ADE9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97142" y="2617114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D0B57D76-6CAA-49D5-A820-68EC65FDD4D4}"/>
                </a:ext>
              </a:extLst>
            </p:cNvPr>
            <p:cNvGrpSpPr/>
            <p:nvPr/>
          </p:nvGrpSpPr>
          <p:grpSpPr>
            <a:xfrm>
              <a:off x="7700147" y="2592131"/>
              <a:ext cx="1377205" cy="782422"/>
              <a:chOff x="7700147" y="2592131"/>
              <a:chExt cx="1377205" cy="782422"/>
            </a:xfrm>
          </p:grpSpPr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3D2131A4-5E66-4D14-947F-9CFDEECF16F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09352" y="2996553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48E517CE-8DE5-4803-8E2F-EAF35939EBD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00147" y="2592131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5C2B527E-9333-4DD9-88E8-6BF9D6BBCF13}"/>
                </a:ext>
              </a:extLst>
            </p:cNvPr>
            <p:cNvGrpSpPr/>
            <p:nvPr/>
          </p:nvGrpSpPr>
          <p:grpSpPr>
            <a:xfrm>
              <a:off x="9102572" y="2588701"/>
              <a:ext cx="1368002" cy="785852"/>
              <a:chOff x="9315748" y="2562279"/>
              <a:chExt cx="1368002" cy="785852"/>
            </a:xfrm>
          </p:grpSpPr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C55074FA-B6C4-45CD-A582-4605F96D737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15748" y="2970131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8685BD09-7327-4C95-B9DE-BE39972E765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15750" y="2562279"/>
                <a:ext cx="1368000" cy="378000"/>
              </a:xfrm>
              <a:prstGeom prst="rect">
                <a:avLst/>
              </a:prstGeom>
            </p:spPr>
          </p:pic>
        </p:grpSp>
      </p:grpSp>
      <p:sp>
        <p:nvSpPr>
          <p:cNvPr id="91" name="文本框 90">
            <a:extLst>
              <a:ext uri="{FF2B5EF4-FFF2-40B4-BE49-F238E27FC236}">
                <a16:creationId xmlns:a16="http://schemas.microsoft.com/office/drawing/2014/main" id="{7E77D104-363B-4BA3-A572-77A347CDD3F3}"/>
              </a:ext>
            </a:extLst>
          </p:cNvPr>
          <p:cNvSpPr txBox="1"/>
          <p:nvPr/>
        </p:nvSpPr>
        <p:spPr>
          <a:xfrm>
            <a:off x="5308189" y="3035647"/>
            <a:ext cx="1042171" cy="11006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P2</a:t>
            </a:r>
          </a:p>
          <a:p>
            <a:pPr algn="r"/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BDD1E1C-CD6C-4134-B12C-7AA9569408C1}"/>
              </a:ext>
            </a:extLst>
          </p:cNvPr>
          <p:cNvGrpSpPr/>
          <p:nvPr/>
        </p:nvGrpSpPr>
        <p:grpSpPr>
          <a:xfrm>
            <a:off x="5917033" y="3847778"/>
            <a:ext cx="2838282" cy="497545"/>
            <a:chOff x="5842693" y="1543207"/>
            <a:chExt cx="2838282" cy="497545"/>
          </a:xfrm>
        </p:grpSpPr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7165017C-9F39-4D87-AD2D-7CBF7AFB9779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50E195EE-5DAF-4143-8CFA-4A61C98382DE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D20FA2BE-AE68-4248-B8A4-ED20A222D2F7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EA739589-D2BE-4FFD-BE75-C808B46E5D7D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25B8C3E6-0D84-4ED3-A91C-1C22BB4B63D3}"/>
              </a:ext>
            </a:extLst>
          </p:cNvPr>
          <p:cNvGrpSpPr/>
          <p:nvPr/>
        </p:nvGrpSpPr>
        <p:grpSpPr>
          <a:xfrm>
            <a:off x="7712375" y="3851498"/>
            <a:ext cx="2838282" cy="497545"/>
            <a:chOff x="5842693" y="1543207"/>
            <a:chExt cx="2838282" cy="497545"/>
          </a:xfrm>
        </p:grpSpPr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A5A494E8-6DAD-4AD6-9FFE-F76018304E5F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BFF24AA6-8D72-40BF-BFF9-A55BAE7E4465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9D7DEB4-8588-4F5F-A72A-D7D116FE6FD2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15E9F8DF-E4CE-4B48-A4C6-7053D2E69E01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grpSp>
        <p:nvGrpSpPr>
          <p:cNvPr id="125" name="组合 124">
            <a:extLst>
              <a:ext uri="{FF2B5EF4-FFF2-40B4-BE49-F238E27FC236}">
                <a16:creationId xmlns:a16="http://schemas.microsoft.com/office/drawing/2014/main" id="{CC868416-F8EA-4AAF-9726-AA125AE049AF}"/>
              </a:ext>
            </a:extLst>
          </p:cNvPr>
          <p:cNvGrpSpPr/>
          <p:nvPr/>
        </p:nvGrpSpPr>
        <p:grpSpPr>
          <a:xfrm>
            <a:off x="9596081" y="3847773"/>
            <a:ext cx="2838282" cy="497545"/>
            <a:chOff x="5842693" y="1543207"/>
            <a:chExt cx="2838282" cy="497545"/>
          </a:xfrm>
        </p:grpSpPr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79BA86F1-C609-44AB-86BA-31950D0621D8}"/>
                </a:ext>
              </a:extLst>
            </p:cNvPr>
            <p:cNvSpPr txBox="1"/>
            <p:nvPr/>
          </p:nvSpPr>
          <p:spPr>
            <a:xfrm rot="18900000">
              <a:off x="5897900" y="1632587"/>
              <a:ext cx="850501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NC</a:t>
              </a:r>
              <a:endParaRPr lang="zh-CN" altLang="en-US" sz="1200" b="1" dirty="0"/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447A8395-BCA8-4CF3-AC34-BC52A83866FF}"/>
                </a:ext>
              </a:extLst>
            </p:cNvPr>
            <p:cNvSpPr txBox="1"/>
            <p:nvPr/>
          </p:nvSpPr>
          <p:spPr>
            <a:xfrm rot="18900000">
              <a:off x="5842693" y="1763752"/>
              <a:ext cx="1405559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  <a:endParaRPr lang="zh-CN" altLang="en-US" sz="1200" b="1" dirty="0"/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83D54306-7762-4BE0-AEE8-C2A969F47577}"/>
                </a:ext>
              </a:extLst>
            </p:cNvPr>
            <p:cNvSpPr txBox="1"/>
            <p:nvPr/>
          </p:nvSpPr>
          <p:spPr>
            <a:xfrm rot="18900000">
              <a:off x="6219263" y="1565024"/>
              <a:ext cx="1852921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ov-SKP2</a:t>
              </a:r>
              <a:endParaRPr lang="zh-CN" altLang="en-US" sz="1200" b="1" dirty="0"/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293EEBFC-C837-4DC7-8B25-0457A0817F32}"/>
                </a:ext>
              </a:extLst>
            </p:cNvPr>
            <p:cNvSpPr txBox="1"/>
            <p:nvPr/>
          </p:nvSpPr>
          <p:spPr>
            <a:xfrm rot="18900000">
              <a:off x="6688999" y="1543207"/>
              <a:ext cx="1991976" cy="461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-lincSCRG1</a:t>
              </a:r>
            </a:p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in-miR26a</a:t>
              </a:r>
              <a:endParaRPr lang="zh-CN" altLang="en-US" sz="1200" b="1" dirty="0"/>
            </a:p>
          </p:txBody>
        </p:sp>
      </p:grpSp>
      <p:grpSp>
        <p:nvGrpSpPr>
          <p:cNvPr id="182" name="组合 181">
            <a:extLst>
              <a:ext uri="{FF2B5EF4-FFF2-40B4-BE49-F238E27FC236}">
                <a16:creationId xmlns:a16="http://schemas.microsoft.com/office/drawing/2014/main" id="{C2AF0B35-D8BC-428C-81C6-E95B9C9C67AC}"/>
              </a:ext>
            </a:extLst>
          </p:cNvPr>
          <p:cNvGrpSpPr/>
          <p:nvPr/>
        </p:nvGrpSpPr>
        <p:grpSpPr>
          <a:xfrm>
            <a:off x="3380404" y="3674454"/>
            <a:ext cx="2388546" cy="417211"/>
            <a:chOff x="415041" y="1472403"/>
            <a:chExt cx="2388546" cy="417211"/>
          </a:xfrm>
        </p:grpSpPr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0AE6A045-9A14-4684-B927-9B49EEA2CDFE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84" name="文本框 183">
              <a:extLst>
                <a:ext uri="{FF2B5EF4-FFF2-40B4-BE49-F238E27FC236}">
                  <a16:creationId xmlns:a16="http://schemas.microsoft.com/office/drawing/2014/main" id="{11691E78-DC1B-4BFC-9AA4-822244782CF2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grpSp>
        <p:nvGrpSpPr>
          <p:cNvPr id="185" name="组合 184">
            <a:extLst>
              <a:ext uri="{FF2B5EF4-FFF2-40B4-BE49-F238E27FC236}">
                <a16:creationId xmlns:a16="http://schemas.microsoft.com/office/drawing/2014/main" id="{1A660F2F-8FDB-41A7-840F-D8EAB4CEC34E}"/>
              </a:ext>
            </a:extLst>
          </p:cNvPr>
          <p:cNvGrpSpPr/>
          <p:nvPr/>
        </p:nvGrpSpPr>
        <p:grpSpPr>
          <a:xfrm>
            <a:off x="1965264" y="3670098"/>
            <a:ext cx="2388546" cy="417211"/>
            <a:chOff x="415041" y="1472403"/>
            <a:chExt cx="2388546" cy="417211"/>
          </a:xfrm>
        </p:grpSpPr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3800A6A5-8171-4244-8FFB-D95314F98165}"/>
                </a:ext>
              </a:extLst>
            </p:cNvPr>
            <p:cNvSpPr txBox="1"/>
            <p:nvPr/>
          </p:nvSpPr>
          <p:spPr>
            <a:xfrm rot="18900000">
              <a:off x="415041" y="1612615"/>
              <a:ext cx="10816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-NC </a:t>
              </a: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52FF744A-96BC-49B4-930C-B4A4DF2C7E86}"/>
                </a:ext>
              </a:extLst>
            </p:cNvPr>
            <p:cNvSpPr txBox="1"/>
            <p:nvPr/>
          </p:nvSpPr>
          <p:spPr>
            <a:xfrm rot="18900000">
              <a:off x="752406" y="1472403"/>
              <a:ext cx="2051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-miR26a </a:t>
              </a:r>
              <a:endParaRPr lang="zh-CN" altLang="en-US" sz="1200" dirty="0"/>
            </a:p>
          </p:txBody>
        </p:sp>
      </p:grpSp>
      <p:sp>
        <p:nvSpPr>
          <p:cNvPr id="106" name="文本框 105">
            <a:extLst>
              <a:ext uri="{FF2B5EF4-FFF2-40B4-BE49-F238E27FC236}">
                <a16:creationId xmlns:a16="http://schemas.microsoft.com/office/drawing/2014/main" id="{B8F05FBD-604E-4EF9-ADC9-20562004AC68}"/>
              </a:ext>
            </a:extLst>
          </p:cNvPr>
          <p:cNvSpPr txBox="1"/>
          <p:nvPr/>
        </p:nvSpPr>
        <p:spPr>
          <a:xfrm>
            <a:off x="5293384" y="-14763"/>
            <a:ext cx="1254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S1-B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FE310C9-5E82-4F50-BBA5-97F17937B94D}"/>
              </a:ext>
            </a:extLst>
          </p:cNvPr>
          <p:cNvSpPr txBox="1"/>
          <p:nvPr/>
        </p:nvSpPr>
        <p:spPr>
          <a:xfrm>
            <a:off x="133815" y="5346522"/>
            <a:ext cx="1169391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1 SKP2 protein expression in HCC cells.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xpressions of SKP2 proteins were reduced in mi-miR26a compared to mi-NC cells in both SNU-387 and  Hep3B cell lines. (B) Co-transfected of ov-SKP2 or in-miR26a </a:t>
            </a:r>
            <a:r>
              <a:rPr lang="en-US" altLang="zh-CN" sz="180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ith sh-lincSCRG1could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scue the depletion of SKP2 protein inducing by sh-lincSCRG1 in 2 cell lines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66354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组合 19">
            <a:extLst>
              <a:ext uri="{FF2B5EF4-FFF2-40B4-BE49-F238E27FC236}">
                <a16:creationId xmlns:a16="http://schemas.microsoft.com/office/drawing/2014/main" id="{FA167E8C-6CE7-48D1-A881-43F152128B56}"/>
              </a:ext>
            </a:extLst>
          </p:cNvPr>
          <p:cNvGrpSpPr/>
          <p:nvPr/>
        </p:nvGrpSpPr>
        <p:grpSpPr>
          <a:xfrm>
            <a:off x="791856" y="949236"/>
            <a:ext cx="4845843" cy="3529058"/>
            <a:chOff x="630669" y="839244"/>
            <a:chExt cx="4154728" cy="4105076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8739F0D2-2B44-4935-94D2-F7F9045DADA6}"/>
                </a:ext>
              </a:extLst>
            </p:cNvPr>
            <p:cNvGrpSpPr/>
            <p:nvPr/>
          </p:nvGrpSpPr>
          <p:grpSpPr>
            <a:xfrm>
              <a:off x="630669" y="1672077"/>
              <a:ext cx="4142184" cy="379995"/>
              <a:chOff x="623546" y="523002"/>
              <a:chExt cx="4142184" cy="379995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124004FF-3594-4CB4-8096-89CAE4D6143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3546" y="523261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0868CB80-4CF3-400E-A2FD-592C4553B67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9688" y="52300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69613A39-63B2-4AD4-A78F-70538D945DC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97730" y="524997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F917B6E4-198B-492A-A55F-DFD6B8728791}"/>
                </a:ext>
              </a:extLst>
            </p:cNvPr>
            <p:cNvGrpSpPr/>
            <p:nvPr/>
          </p:nvGrpSpPr>
          <p:grpSpPr>
            <a:xfrm>
              <a:off x="632255" y="839244"/>
              <a:ext cx="4133475" cy="383625"/>
              <a:chOff x="632255" y="960686"/>
              <a:chExt cx="4133475" cy="383625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3726C039-B9C5-47FA-BBF1-2971DB4659F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96068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B88699FB-56A3-4552-83F5-0DCE1DC27A7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9688" y="963633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F8F3BBC4-8613-431B-B42C-255FF05E61E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97730" y="966311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9ED12373-752C-4D77-9C98-AC6B953C03AE}"/>
                </a:ext>
              </a:extLst>
            </p:cNvPr>
            <p:cNvGrpSpPr/>
            <p:nvPr/>
          </p:nvGrpSpPr>
          <p:grpSpPr>
            <a:xfrm>
              <a:off x="632255" y="1247103"/>
              <a:ext cx="4142866" cy="386161"/>
              <a:chOff x="632255" y="1425699"/>
              <a:chExt cx="4142866" cy="386161"/>
            </a:xfrm>
          </p:grpSpPr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5E241376-0E18-4275-A66A-DD08CF435F7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1433860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5C6F5862-0FC8-4FE7-8903-F92F7B43661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9688" y="1425699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E6C37834-723C-4C04-88A7-E3C3950777E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07121" y="1433860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03FBF01E-AD48-49BB-8A0F-A0180C06C451}"/>
                </a:ext>
              </a:extLst>
            </p:cNvPr>
            <p:cNvGrpSpPr/>
            <p:nvPr/>
          </p:nvGrpSpPr>
          <p:grpSpPr>
            <a:xfrm>
              <a:off x="632255" y="2077881"/>
              <a:ext cx="4149945" cy="389504"/>
              <a:chOff x="632255" y="1863564"/>
              <a:chExt cx="4149945" cy="389504"/>
            </a:xfrm>
          </p:grpSpPr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D5060099-19FC-46DA-A30D-36DCD1786A4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1875068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829B4D2A-99CF-4143-8ACD-4FFC490837D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4833" y="1863564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01484CBC-8A25-48E4-81CF-A396492771E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4200" y="1863564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87F1ADAC-EE44-4471-848F-95EB520D8697}"/>
                </a:ext>
              </a:extLst>
            </p:cNvPr>
            <p:cNvGrpSpPr/>
            <p:nvPr/>
          </p:nvGrpSpPr>
          <p:grpSpPr>
            <a:xfrm>
              <a:off x="632255" y="2496278"/>
              <a:ext cx="4149896" cy="384225"/>
              <a:chOff x="632255" y="2331967"/>
              <a:chExt cx="4149896" cy="384225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8712E4A7-0AE1-406F-A85C-64B97F4015A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233196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B4668AC4-174C-41A1-AE44-561AD471F41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3203" y="233819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B6275D69-686C-489E-A58B-C6AC9EBE0E7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4151" y="2334452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7604E0D4-9F01-4816-B3D7-5AFCF68DCD84}"/>
                </a:ext>
              </a:extLst>
            </p:cNvPr>
            <p:cNvGrpSpPr/>
            <p:nvPr/>
          </p:nvGrpSpPr>
          <p:grpSpPr>
            <a:xfrm>
              <a:off x="632255" y="2913996"/>
              <a:ext cx="4152811" cy="381783"/>
              <a:chOff x="632255" y="2806836"/>
              <a:chExt cx="4152811" cy="381783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4E20A08F-1DA4-48F5-BB18-383DCADC034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280683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35" name="图片 34">
                <a:extLst>
                  <a:ext uri="{FF2B5EF4-FFF2-40B4-BE49-F238E27FC236}">
                    <a16:creationId xmlns:a16="http://schemas.microsoft.com/office/drawing/2014/main" id="{98E66AFB-1928-4803-A4E0-CB37F9CA41A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9022" y="280683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CFC50382-B6CD-47A6-8A5F-78BDCD5B8D5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7066" y="2810619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1063ED06-5D82-4F0A-B377-429A21CB0EE1}"/>
                </a:ext>
              </a:extLst>
            </p:cNvPr>
            <p:cNvGrpSpPr/>
            <p:nvPr/>
          </p:nvGrpSpPr>
          <p:grpSpPr>
            <a:xfrm>
              <a:off x="640964" y="3331912"/>
              <a:ext cx="4142033" cy="384971"/>
              <a:chOff x="632255" y="3282787"/>
              <a:chExt cx="4142033" cy="384971"/>
            </a:xfrm>
          </p:grpSpPr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B2795310-B569-4365-86F3-1645299C102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3287099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3BF76C6B-5014-435D-AF2C-885BF584E4B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7624" y="328278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BD628CC3-800E-4728-B1F9-C9BF62140FD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06288" y="3289758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65C0D1AF-4619-4EAF-8D7E-F6CBB52C0781}"/>
                </a:ext>
              </a:extLst>
            </p:cNvPr>
            <p:cNvGrpSpPr/>
            <p:nvPr/>
          </p:nvGrpSpPr>
          <p:grpSpPr>
            <a:xfrm>
              <a:off x="637334" y="3739606"/>
              <a:ext cx="4145998" cy="381937"/>
              <a:chOff x="632255" y="3748835"/>
              <a:chExt cx="4145998" cy="381937"/>
            </a:xfrm>
          </p:grpSpPr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D2CDEB9D-0720-4C4C-8A17-C1999A5FB58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375277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F75DE2AA-A2A0-46C0-AD95-0CAD5C93312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17624" y="375277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4764E9FD-6F97-4401-9410-8959B8B968B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0253" y="3748835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244AB964-DCDE-4F27-9714-45E0483437CA}"/>
                </a:ext>
              </a:extLst>
            </p:cNvPr>
            <p:cNvGrpSpPr/>
            <p:nvPr/>
          </p:nvGrpSpPr>
          <p:grpSpPr>
            <a:xfrm>
              <a:off x="632255" y="4148469"/>
              <a:ext cx="4149177" cy="384114"/>
              <a:chOff x="632255" y="4162892"/>
              <a:chExt cx="4149177" cy="384114"/>
            </a:xfrm>
          </p:grpSpPr>
          <p:pic>
            <p:nvPicPr>
              <p:cNvPr id="51" name="图片 50">
                <a:extLst>
                  <a:ext uri="{FF2B5EF4-FFF2-40B4-BE49-F238E27FC236}">
                    <a16:creationId xmlns:a16="http://schemas.microsoft.com/office/drawing/2014/main" id="{63622646-BACD-4B09-9E5E-4DC087F88B7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416900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E5639B44-634F-4AB2-B7B8-05BDD5CF624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2586" y="416289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70C883AC-640F-483A-8A51-A6CD9B5A42E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3432" y="4162892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62" name="组合 61">
              <a:extLst>
                <a:ext uri="{FF2B5EF4-FFF2-40B4-BE49-F238E27FC236}">
                  <a16:creationId xmlns:a16="http://schemas.microsoft.com/office/drawing/2014/main" id="{00A4C925-D7D5-4AD6-B9B7-133C22841D67}"/>
                </a:ext>
              </a:extLst>
            </p:cNvPr>
            <p:cNvGrpSpPr/>
            <p:nvPr/>
          </p:nvGrpSpPr>
          <p:grpSpPr>
            <a:xfrm>
              <a:off x="632255" y="4556863"/>
              <a:ext cx="4153142" cy="387457"/>
              <a:chOff x="632255" y="4600757"/>
              <a:chExt cx="4153142" cy="387457"/>
            </a:xfrm>
          </p:grpSpPr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1D2FE7FD-2B20-4DCE-AEA4-51969DDB430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2255" y="4610214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9" name="图片 58">
                <a:extLst>
                  <a:ext uri="{FF2B5EF4-FFF2-40B4-BE49-F238E27FC236}">
                    <a16:creationId xmlns:a16="http://schemas.microsoft.com/office/drawing/2014/main" id="{F39F8F11-2575-4011-9CE8-976B868D864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24833" y="460075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1" name="图片 60">
                <a:extLst>
                  <a:ext uri="{FF2B5EF4-FFF2-40B4-BE49-F238E27FC236}">
                    <a16:creationId xmlns:a16="http://schemas.microsoft.com/office/drawing/2014/main" id="{0526DBB6-56C8-4B3A-9256-D7DFB9E2C6D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17397" y="4600757"/>
                <a:ext cx="1368000" cy="378000"/>
              </a:xfrm>
              <a:prstGeom prst="rect">
                <a:avLst/>
              </a:prstGeom>
            </p:spPr>
          </p:pic>
        </p:grpSp>
      </p:grpSp>
      <p:sp>
        <p:nvSpPr>
          <p:cNvPr id="79" name="文本框 78">
            <a:extLst>
              <a:ext uri="{FF2B5EF4-FFF2-40B4-BE49-F238E27FC236}">
                <a16:creationId xmlns:a16="http://schemas.microsoft.com/office/drawing/2014/main" id="{BDAD96AF-06FD-4593-8519-14C286006EF9}"/>
              </a:ext>
            </a:extLst>
          </p:cNvPr>
          <p:cNvSpPr txBox="1"/>
          <p:nvPr/>
        </p:nvSpPr>
        <p:spPr>
          <a:xfrm>
            <a:off x="2485847" y="253244"/>
            <a:ext cx="2234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U-387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24FFEF6A-6666-4632-96AE-ABF1CA74F3AA}"/>
              </a:ext>
            </a:extLst>
          </p:cNvPr>
          <p:cNvGrpSpPr/>
          <p:nvPr/>
        </p:nvGrpSpPr>
        <p:grpSpPr>
          <a:xfrm>
            <a:off x="6960700" y="949235"/>
            <a:ext cx="4682660" cy="3529058"/>
            <a:chOff x="5744255" y="816618"/>
            <a:chExt cx="4170611" cy="4124016"/>
          </a:xfrm>
        </p:grpSpPr>
        <p:grpSp>
          <p:nvGrpSpPr>
            <p:cNvPr id="103" name="组合 102">
              <a:extLst>
                <a:ext uri="{FF2B5EF4-FFF2-40B4-BE49-F238E27FC236}">
                  <a16:creationId xmlns:a16="http://schemas.microsoft.com/office/drawing/2014/main" id="{D414DD14-1A74-4721-A183-7A8F0677EF46}"/>
                </a:ext>
              </a:extLst>
            </p:cNvPr>
            <p:cNvGrpSpPr/>
            <p:nvPr/>
          </p:nvGrpSpPr>
          <p:grpSpPr>
            <a:xfrm>
              <a:off x="5744255" y="816618"/>
              <a:ext cx="4154241" cy="378000"/>
              <a:chOff x="5744255" y="816618"/>
              <a:chExt cx="4154241" cy="378000"/>
            </a:xfrm>
          </p:grpSpPr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354617A6-1CC9-4056-A6F1-4427BD7C9A4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816618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A79D94FE-5F7E-4F7B-AD0C-69647DB85B6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1730" y="816618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06B5478F-BBEC-4691-87E7-991FF013673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0496" y="816618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5" name="组合 104">
              <a:extLst>
                <a:ext uri="{FF2B5EF4-FFF2-40B4-BE49-F238E27FC236}">
                  <a16:creationId xmlns:a16="http://schemas.microsoft.com/office/drawing/2014/main" id="{A7A4F211-77B0-4F99-8A1C-B750EA47C866}"/>
                </a:ext>
              </a:extLst>
            </p:cNvPr>
            <p:cNvGrpSpPr/>
            <p:nvPr/>
          </p:nvGrpSpPr>
          <p:grpSpPr>
            <a:xfrm>
              <a:off x="5744255" y="1220583"/>
              <a:ext cx="4162834" cy="378000"/>
              <a:chOff x="5744255" y="1394757"/>
              <a:chExt cx="4162834" cy="378000"/>
            </a:xfrm>
          </p:grpSpPr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60CD276B-0144-483D-B25A-7A7F6C5DC69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139475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6F1A332B-0CFE-4390-992C-E58D8E2499F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1730" y="1394757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B0516814-2525-4120-974B-36F470EECF3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9089" y="1394757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6" name="组合 105">
              <a:extLst>
                <a:ext uri="{FF2B5EF4-FFF2-40B4-BE49-F238E27FC236}">
                  <a16:creationId xmlns:a16="http://schemas.microsoft.com/office/drawing/2014/main" id="{84E629AA-393A-4F17-9CBD-DD41BE7B7DEE}"/>
                </a:ext>
              </a:extLst>
            </p:cNvPr>
            <p:cNvGrpSpPr/>
            <p:nvPr/>
          </p:nvGrpSpPr>
          <p:grpSpPr>
            <a:xfrm>
              <a:off x="5744255" y="1640211"/>
              <a:ext cx="4160240" cy="379120"/>
              <a:chOff x="5744255" y="1997264"/>
              <a:chExt cx="4160240" cy="379120"/>
            </a:xfrm>
          </p:grpSpPr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744AF844-3E16-45D5-ABE9-898325CF644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1998384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5FBE8F24-40B4-4F16-A1C9-1FCBD7ABF2C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1730" y="199761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53328106-69F5-4847-AFF3-72E64F4A0D4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6495" y="1997264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7" name="组合 106">
              <a:extLst>
                <a:ext uri="{FF2B5EF4-FFF2-40B4-BE49-F238E27FC236}">
                  <a16:creationId xmlns:a16="http://schemas.microsoft.com/office/drawing/2014/main" id="{4F22B30B-65D6-42B1-A8A6-C503B278B480}"/>
                </a:ext>
              </a:extLst>
            </p:cNvPr>
            <p:cNvGrpSpPr/>
            <p:nvPr/>
          </p:nvGrpSpPr>
          <p:grpSpPr>
            <a:xfrm>
              <a:off x="5744255" y="2051023"/>
              <a:ext cx="4162834" cy="388632"/>
              <a:chOff x="5744255" y="2451621"/>
              <a:chExt cx="4162834" cy="388632"/>
            </a:xfrm>
          </p:grpSpPr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156A449B-154F-463E-8E76-A1E74CBF86A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2455881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4789FB2F-53A1-4017-A4E8-07535EA1ABE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36833" y="2451621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AD1075EE-BE3D-4AFF-A774-54C6D0831B2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9089" y="2462253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12EA8C54-0D1F-4FAB-AF85-E76551BF79DC}"/>
                </a:ext>
              </a:extLst>
            </p:cNvPr>
            <p:cNvGrpSpPr/>
            <p:nvPr/>
          </p:nvGrpSpPr>
          <p:grpSpPr>
            <a:xfrm>
              <a:off x="5744255" y="2460470"/>
              <a:ext cx="4161902" cy="392468"/>
              <a:chOff x="5744255" y="2939444"/>
              <a:chExt cx="4161902" cy="392468"/>
            </a:xfrm>
          </p:grpSpPr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75A1B7CA-AA9E-4227-B745-DF99D7755F6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295391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0" name="图片 69">
                <a:extLst>
                  <a:ext uri="{FF2B5EF4-FFF2-40B4-BE49-F238E27FC236}">
                    <a16:creationId xmlns:a16="http://schemas.microsoft.com/office/drawing/2014/main" id="{15213D55-1FDF-40AE-A254-29E0CD2B67C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4907" y="2951474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8A20E2FC-E593-4462-A976-AAA9148AC92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8157" y="2939444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09" name="组合 108">
              <a:extLst>
                <a:ext uri="{FF2B5EF4-FFF2-40B4-BE49-F238E27FC236}">
                  <a16:creationId xmlns:a16="http://schemas.microsoft.com/office/drawing/2014/main" id="{96EDAB20-8003-480C-91D8-F9F4EBCCBD36}"/>
                </a:ext>
              </a:extLst>
            </p:cNvPr>
            <p:cNvGrpSpPr/>
            <p:nvPr/>
          </p:nvGrpSpPr>
          <p:grpSpPr>
            <a:xfrm>
              <a:off x="5744255" y="2887054"/>
              <a:ext cx="4170611" cy="385539"/>
              <a:chOff x="5744255" y="3435700"/>
              <a:chExt cx="4170611" cy="385539"/>
            </a:xfrm>
          </p:grpSpPr>
          <p:pic>
            <p:nvPicPr>
              <p:cNvPr id="74" name="图片 73">
                <a:extLst>
                  <a:ext uri="{FF2B5EF4-FFF2-40B4-BE49-F238E27FC236}">
                    <a16:creationId xmlns:a16="http://schemas.microsoft.com/office/drawing/2014/main" id="{E6325DC5-7A69-42F8-81A5-4E1F86AC718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3443239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6" name="图片 75">
                <a:extLst>
                  <a:ext uri="{FF2B5EF4-FFF2-40B4-BE49-F238E27FC236}">
                    <a16:creationId xmlns:a16="http://schemas.microsoft.com/office/drawing/2014/main" id="{6C95D8DF-96FD-44A8-8C43-10F7EE17208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53918" y="3435700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78" name="图片 77">
                <a:extLst>
                  <a:ext uri="{FF2B5EF4-FFF2-40B4-BE49-F238E27FC236}">
                    <a16:creationId xmlns:a16="http://schemas.microsoft.com/office/drawing/2014/main" id="{3E4A567B-EDA9-4B6B-BEC1-3F6919E1A69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6866" y="3435700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10" name="组合 109">
              <a:extLst>
                <a:ext uri="{FF2B5EF4-FFF2-40B4-BE49-F238E27FC236}">
                  <a16:creationId xmlns:a16="http://schemas.microsoft.com/office/drawing/2014/main" id="{F225E0D0-AAA1-49EB-93F1-6CCAAA236736}"/>
                </a:ext>
              </a:extLst>
            </p:cNvPr>
            <p:cNvGrpSpPr/>
            <p:nvPr/>
          </p:nvGrpSpPr>
          <p:grpSpPr>
            <a:xfrm>
              <a:off x="5744255" y="3310298"/>
              <a:ext cx="4165662" cy="379069"/>
              <a:chOff x="5744255" y="3928606"/>
              <a:chExt cx="4165662" cy="379069"/>
            </a:xfrm>
          </p:grpSpPr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6A720717-16B8-42DF-B23B-A39A2E5EBF6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3928606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82" name="图片 81">
                <a:extLst>
                  <a:ext uri="{FF2B5EF4-FFF2-40B4-BE49-F238E27FC236}">
                    <a16:creationId xmlns:a16="http://schemas.microsoft.com/office/drawing/2014/main" id="{05548B66-AD96-40F2-A9FD-3695A91BD87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0597" y="3929675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84" name="图片 83">
                <a:extLst>
                  <a:ext uri="{FF2B5EF4-FFF2-40B4-BE49-F238E27FC236}">
                    <a16:creationId xmlns:a16="http://schemas.microsoft.com/office/drawing/2014/main" id="{3D1B6C6C-6D0D-4F4A-A14C-9B3B45B4A4EB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1917" y="3928606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95B70954-52AD-49C9-8BC8-CD11A1007F0D}"/>
                </a:ext>
              </a:extLst>
            </p:cNvPr>
            <p:cNvGrpSpPr/>
            <p:nvPr/>
          </p:nvGrpSpPr>
          <p:grpSpPr>
            <a:xfrm>
              <a:off x="5744255" y="3721036"/>
              <a:ext cx="4165662" cy="391240"/>
              <a:chOff x="5744255" y="4382892"/>
              <a:chExt cx="4165662" cy="391240"/>
            </a:xfrm>
          </p:grpSpPr>
          <p:pic>
            <p:nvPicPr>
              <p:cNvPr id="86" name="图片 85">
                <a:extLst>
                  <a:ext uri="{FF2B5EF4-FFF2-40B4-BE49-F238E27FC236}">
                    <a16:creationId xmlns:a16="http://schemas.microsoft.com/office/drawing/2014/main" id="{B8DCA58F-40CB-4641-B4E4-FC1725EC1DF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4396132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88" name="图片 87">
                <a:extLst>
                  <a:ext uri="{FF2B5EF4-FFF2-40B4-BE49-F238E27FC236}">
                    <a16:creationId xmlns:a16="http://schemas.microsoft.com/office/drawing/2014/main" id="{E22323E7-3C7D-4849-A4BF-16B3EBB7E1D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4111" y="4390525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90" name="图片 89">
                <a:extLst>
                  <a:ext uri="{FF2B5EF4-FFF2-40B4-BE49-F238E27FC236}">
                    <a16:creationId xmlns:a16="http://schemas.microsoft.com/office/drawing/2014/main" id="{A820E068-130E-401C-998A-53B6458B521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1917" y="4382892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13" name="组合 112">
              <a:extLst>
                <a:ext uri="{FF2B5EF4-FFF2-40B4-BE49-F238E27FC236}">
                  <a16:creationId xmlns:a16="http://schemas.microsoft.com/office/drawing/2014/main" id="{AB8BDF0A-57E2-43D9-9F64-59BBA098FEE3}"/>
                </a:ext>
              </a:extLst>
            </p:cNvPr>
            <p:cNvGrpSpPr/>
            <p:nvPr/>
          </p:nvGrpSpPr>
          <p:grpSpPr>
            <a:xfrm>
              <a:off x="5744255" y="4149611"/>
              <a:ext cx="4163160" cy="381036"/>
              <a:chOff x="5744255" y="4872429"/>
              <a:chExt cx="4163160" cy="381036"/>
            </a:xfrm>
          </p:grpSpPr>
          <p:pic>
            <p:nvPicPr>
              <p:cNvPr id="92" name="图片 91">
                <a:extLst>
                  <a:ext uri="{FF2B5EF4-FFF2-40B4-BE49-F238E27FC236}">
                    <a16:creationId xmlns:a16="http://schemas.microsoft.com/office/drawing/2014/main" id="{0977B0CF-5A7C-4CB5-BFD3-E3F78249543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4872429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94" name="图片 93">
                <a:extLst>
                  <a:ext uri="{FF2B5EF4-FFF2-40B4-BE49-F238E27FC236}">
                    <a16:creationId xmlns:a16="http://schemas.microsoft.com/office/drawing/2014/main" id="{C09E35FF-1CFF-4AC9-9EF4-4B3E97C3491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36819" y="4872429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96" name="图片 95">
                <a:extLst>
                  <a:ext uri="{FF2B5EF4-FFF2-40B4-BE49-F238E27FC236}">
                    <a16:creationId xmlns:a16="http://schemas.microsoft.com/office/drawing/2014/main" id="{3B113289-F166-4648-BAE4-1D72243D8CA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9415" y="4875465"/>
                <a:ext cx="1368000" cy="378000"/>
              </a:xfrm>
              <a:prstGeom prst="rect">
                <a:avLst/>
              </a:prstGeom>
            </p:spPr>
          </p:pic>
        </p:grpSp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BB3C7E58-317B-4CFB-9A3E-094D6384492F}"/>
                </a:ext>
              </a:extLst>
            </p:cNvPr>
            <p:cNvGrpSpPr/>
            <p:nvPr/>
          </p:nvGrpSpPr>
          <p:grpSpPr>
            <a:xfrm>
              <a:off x="5744255" y="4562634"/>
              <a:ext cx="4163160" cy="378000"/>
              <a:chOff x="5744255" y="5302870"/>
              <a:chExt cx="4163160" cy="378000"/>
            </a:xfrm>
          </p:grpSpPr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D88636BB-3956-464E-B562-FB5D928B125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44255" y="5302870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00" name="图片 99">
                <a:extLst>
                  <a:ext uri="{FF2B5EF4-FFF2-40B4-BE49-F238E27FC236}">
                    <a16:creationId xmlns:a16="http://schemas.microsoft.com/office/drawing/2014/main" id="{1030D2E8-C2C5-4651-A69B-A79EB065EBD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44907" y="5302870"/>
                <a:ext cx="1368000" cy="378000"/>
              </a:xfrm>
              <a:prstGeom prst="rect">
                <a:avLst/>
              </a:prstGeom>
            </p:spPr>
          </p:pic>
          <p:pic>
            <p:nvPicPr>
              <p:cNvPr id="102" name="图片 101">
                <a:extLst>
                  <a:ext uri="{FF2B5EF4-FFF2-40B4-BE49-F238E27FC236}">
                    <a16:creationId xmlns:a16="http://schemas.microsoft.com/office/drawing/2014/main" id="{D9E4DA88-9F21-43B8-8A93-FFB7F223C99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39415" y="5302870"/>
                <a:ext cx="1368000" cy="378000"/>
              </a:xfrm>
              <a:prstGeom prst="rect">
                <a:avLst/>
              </a:prstGeom>
            </p:spPr>
          </p:pic>
        </p:grpSp>
      </p:grpSp>
      <p:sp>
        <p:nvSpPr>
          <p:cNvPr id="127" name="文本框 126">
            <a:extLst>
              <a:ext uri="{FF2B5EF4-FFF2-40B4-BE49-F238E27FC236}">
                <a16:creationId xmlns:a16="http://schemas.microsoft.com/office/drawing/2014/main" id="{A21F5C8C-959E-426A-B9DD-D053D1365846}"/>
              </a:ext>
            </a:extLst>
          </p:cNvPr>
          <p:cNvSpPr txBox="1"/>
          <p:nvPr/>
        </p:nvSpPr>
        <p:spPr>
          <a:xfrm>
            <a:off x="11563645" y="921670"/>
            <a:ext cx="924455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ED47E19-BC11-4886-B611-58F201835C7A}"/>
              </a:ext>
            </a:extLst>
          </p:cNvPr>
          <p:cNvSpPr txBox="1"/>
          <p:nvPr/>
        </p:nvSpPr>
        <p:spPr>
          <a:xfrm>
            <a:off x="5920129" y="817794"/>
            <a:ext cx="1098980" cy="3729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6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2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3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9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DBF635E8-BE04-47E5-AF64-5615229F8454}"/>
              </a:ext>
            </a:extLst>
          </p:cNvPr>
          <p:cNvSpPr txBox="1"/>
          <p:nvPr/>
        </p:nvSpPr>
        <p:spPr>
          <a:xfrm>
            <a:off x="8770088" y="273145"/>
            <a:ext cx="22900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p3B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E401ED49-B9EE-4D33-8855-13A2D9DD73B5}"/>
              </a:ext>
            </a:extLst>
          </p:cNvPr>
          <p:cNvSpPr txBox="1"/>
          <p:nvPr/>
        </p:nvSpPr>
        <p:spPr>
          <a:xfrm>
            <a:off x="-258508" y="867687"/>
            <a:ext cx="1098980" cy="37293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4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K6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inD1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2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3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-9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</a:p>
          <a:p>
            <a:pPr algn="r">
              <a:lnSpc>
                <a:spcPct val="20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33AF9AD7-F9EC-4FF2-83C2-E1282BCFC623}"/>
              </a:ext>
            </a:extLst>
          </p:cNvPr>
          <p:cNvSpPr txBox="1"/>
          <p:nvPr/>
        </p:nvSpPr>
        <p:spPr>
          <a:xfrm>
            <a:off x="5546194" y="967096"/>
            <a:ext cx="924455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5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KD</a:t>
            </a:r>
          </a:p>
          <a:p>
            <a:endParaRPr lang="en-US" altLang="zh-C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1FC207C1-07A4-4F07-9EA9-AB4A26E54743}"/>
              </a:ext>
            </a:extLst>
          </p:cNvPr>
          <p:cNvGrpSpPr/>
          <p:nvPr/>
        </p:nvGrpSpPr>
        <p:grpSpPr>
          <a:xfrm>
            <a:off x="6801233" y="567490"/>
            <a:ext cx="4947116" cy="364563"/>
            <a:chOff x="6801233" y="567490"/>
            <a:chExt cx="4947116" cy="364563"/>
          </a:xfrm>
        </p:grpSpPr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9C24BE09-3C7B-4716-9D2D-E3143AB88A2A}"/>
                </a:ext>
              </a:extLst>
            </p:cNvPr>
            <p:cNvGrpSpPr/>
            <p:nvPr/>
          </p:nvGrpSpPr>
          <p:grpSpPr>
            <a:xfrm>
              <a:off x="6801233" y="593499"/>
              <a:ext cx="1721552" cy="338554"/>
              <a:chOff x="6801233" y="593499"/>
              <a:chExt cx="1721552" cy="338554"/>
            </a:xfrm>
          </p:grpSpPr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B6DC922-36B3-4E9D-A8BB-738897051735}"/>
                  </a:ext>
                </a:extLst>
              </p:cNvPr>
              <p:cNvSpPr txBox="1"/>
              <p:nvPr/>
            </p:nvSpPr>
            <p:spPr>
              <a:xfrm>
                <a:off x="6801233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4" name="直接连接符 53">
                <a:extLst>
                  <a:ext uri="{FF2B5EF4-FFF2-40B4-BE49-F238E27FC236}">
                    <a16:creationId xmlns:a16="http://schemas.microsoft.com/office/drawing/2014/main" id="{E9A68D9E-7C1B-4F1C-80D1-7C1163399FD8}"/>
                  </a:ext>
                </a:extLst>
              </p:cNvPr>
              <p:cNvCxnSpPr>
                <a:cxnSpLocks/>
                <a:endCxn id="132" idx="1"/>
              </p:cNvCxnSpPr>
              <p:nvPr/>
            </p:nvCxnSpPr>
            <p:spPr>
              <a:xfrm flipV="1">
                <a:off x="7288539" y="736767"/>
                <a:ext cx="1136653" cy="14562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组合 130">
              <a:extLst>
                <a:ext uri="{FF2B5EF4-FFF2-40B4-BE49-F238E27FC236}">
                  <a16:creationId xmlns:a16="http://schemas.microsoft.com/office/drawing/2014/main" id="{62A1C97C-86A1-4952-BBEF-E43E04FBA4F3}"/>
                </a:ext>
              </a:extLst>
            </p:cNvPr>
            <p:cNvGrpSpPr/>
            <p:nvPr/>
          </p:nvGrpSpPr>
          <p:grpSpPr>
            <a:xfrm>
              <a:off x="8425192" y="567490"/>
              <a:ext cx="1721552" cy="338554"/>
              <a:chOff x="6905738" y="593499"/>
              <a:chExt cx="1721552" cy="338554"/>
            </a:xfrm>
          </p:grpSpPr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7866054E-565C-4B7F-80A3-C33065F13B7B}"/>
                  </a:ext>
                </a:extLst>
              </p:cNvPr>
              <p:cNvSpPr txBox="1"/>
              <p:nvPr/>
            </p:nvSpPr>
            <p:spPr>
              <a:xfrm>
                <a:off x="6905738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3" name="直接连接符 132">
                <a:extLst>
                  <a:ext uri="{FF2B5EF4-FFF2-40B4-BE49-F238E27FC236}">
                    <a16:creationId xmlns:a16="http://schemas.microsoft.com/office/drawing/2014/main" id="{683CF010-F628-48D1-BBA5-1720EAE0CC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93044" y="751328"/>
                <a:ext cx="111544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组合 133">
              <a:extLst>
                <a:ext uri="{FF2B5EF4-FFF2-40B4-BE49-F238E27FC236}">
                  <a16:creationId xmlns:a16="http://schemas.microsoft.com/office/drawing/2014/main" id="{128C5817-856D-4CE1-9F8A-FB9C967998A9}"/>
                </a:ext>
              </a:extLst>
            </p:cNvPr>
            <p:cNvGrpSpPr/>
            <p:nvPr/>
          </p:nvGrpSpPr>
          <p:grpSpPr>
            <a:xfrm>
              <a:off x="10026797" y="576596"/>
              <a:ext cx="1721552" cy="338554"/>
              <a:chOff x="6905738" y="593499"/>
              <a:chExt cx="1721552" cy="338554"/>
            </a:xfrm>
          </p:grpSpPr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950E69B0-808C-46CE-9297-58784A822812}"/>
                  </a:ext>
                </a:extLst>
              </p:cNvPr>
              <p:cNvSpPr txBox="1"/>
              <p:nvPr/>
            </p:nvSpPr>
            <p:spPr>
              <a:xfrm>
                <a:off x="6905738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6" name="直接连接符 135">
                <a:extLst>
                  <a:ext uri="{FF2B5EF4-FFF2-40B4-BE49-F238E27FC236}">
                    <a16:creationId xmlns:a16="http://schemas.microsoft.com/office/drawing/2014/main" id="{10E1835F-A18E-44BB-9626-187F1A52FD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93044" y="751328"/>
                <a:ext cx="111544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7" name="组合 136">
            <a:extLst>
              <a:ext uri="{FF2B5EF4-FFF2-40B4-BE49-F238E27FC236}">
                <a16:creationId xmlns:a16="http://schemas.microsoft.com/office/drawing/2014/main" id="{9D558022-A6ED-4165-A9CA-48E42FC281DF}"/>
              </a:ext>
            </a:extLst>
          </p:cNvPr>
          <p:cNvGrpSpPr/>
          <p:nvPr/>
        </p:nvGrpSpPr>
        <p:grpSpPr>
          <a:xfrm>
            <a:off x="693609" y="614098"/>
            <a:ext cx="4947116" cy="364563"/>
            <a:chOff x="6801233" y="567490"/>
            <a:chExt cx="4947116" cy="364563"/>
          </a:xfrm>
        </p:grpSpPr>
        <p:grpSp>
          <p:nvGrpSpPr>
            <p:cNvPr id="138" name="组合 137">
              <a:extLst>
                <a:ext uri="{FF2B5EF4-FFF2-40B4-BE49-F238E27FC236}">
                  <a16:creationId xmlns:a16="http://schemas.microsoft.com/office/drawing/2014/main" id="{41244E69-4F18-42A7-BEA7-E14D4803862E}"/>
                </a:ext>
              </a:extLst>
            </p:cNvPr>
            <p:cNvGrpSpPr/>
            <p:nvPr/>
          </p:nvGrpSpPr>
          <p:grpSpPr>
            <a:xfrm>
              <a:off x="6801233" y="593499"/>
              <a:ext cx="1721552" cy="338554"/>
              <a:chOff x="6801233" y="593499"/>
              <a:chExt cx="1721552" cy="338554"/>
            </a:xfrm>
          </p:grpSpPr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FFEB0E49-58B6-4938-80DD-0FA63418812E}"/>
                  </a:ext>
                </a:extLst>
              </p:cNvPr>
              <p:cNvSpPr txBox="1"/>
              <p:nvPr/>
            </p:nvSpPr>
            <p:spPr>
              <a:xfrm>
                <a:off x="6801233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6" name="直接连接符 145">
                <a:extLst>
                  <a:ext uri="{FF2B5EF4-FFF2-40B4-BE49-F238E27FC236}">
                    <a16:creationId xmlns:a16="http://schemas.microsoft.com/office/drawing/2014/main" id="{D96627C1-B4C7-47E7-B0EB-5334DBB90387}"/>
                  </a:ext>
                </a:extLst>
              </p:cNvPr>
              <p:cNvCxnSpPr>
                <a:cxnSpLocks/>
                <a:endCxn id="143" idx="1"/>
              </p:cNvCxnSpPr>
              <p:nvPr/>
            </p:nvCxnSpPr>
            <p:spPr>
              <a:xfrm flipV="1">
                <a:off x="7288539" y="736767"/>
                <a:ext cx="1136653" cy="14562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9" name="组合 138">
              <a:extLst>
                <a:ext uri="{FF2B5EF4-FFF2-40B4-BE49-F238E27FC236}">
                  <a16:creationId xmlns:a16="http://schemas.microsoft.com/office/drawing/2014/main" id="{A80D1B68-4ED5-44C6-9CCE-71067BC5F373}"/>
                </a:ext>
              </a:extLst>
            </p:cNvPr>
            <p:cNvGrpSpPr/>
            <p:nvPr/>
          </p:nvGrpSpPr>
          <p:grpSpPr>
            <a:xfrm>
              <a:off x="8425192" y="567490"/>
              <a:ext cx="1721552" cy="338554"/>
              <a:chOff x="6905738" y="593499"/>
              <a:chExt cx="1721552" cy="338554"/>
            </a:xfrm>
          </p:grpSpPr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2F889AE4-4578-413B-9AEC-713D100C444C}"/>
                  </a:ext>
                </a:extLst>
              </p:cNvPr>
              <p:cNvSpPr txBox="1"/>
              <p:nvPr/>
            </p:nvSpPr>
            <p:spPr>
              <a:xfrm>
                <a:off x="6905738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4" name="直接连接符 143">
                <a:extLst>
                  <a:ext uri="{FF2B5EF4-FFF2-40B4-BE49-F238E27FC236}">
                    <a16:creationId xmlns:a16="http://schemas.microsoft.com/office/drawing/2014/main" id="{31D76E00-C4F4-4C09-813A-8B26B87735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93044" y="751328"/>
                <a:ext cx="111544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0" name="组合 139">
              <a:extLst>
                <a:ext uri="{FF2B5EF4-FFF2-40B4-BE49-F238E27FC236}">
                  <a16:creationId xmlns:a16="http://schemas.microsoft.com/office/drawing/2014/main" id="{281267B4-3DDE-4493-AC74-2331983FA05E}"/>
                </a:ext>
              </a:extLst>
            </p:cNvPr>
            <p:cNvGrpSpPr/>
            <p:nvPr/>
          </p:nvGrpSpPr>
          <p:grpSpPr>
            <a:xfrm>
              <a:off x="10026797" y="576596"/>
              <a:ext cx="1721552" cy="338554"/>
              <a:chOff x="6905738" y="593499"/>
              <a:chExt cx="1721552" cy="338554"/>
            </a:xfrm>
          </p:grpSpPr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DFB88619-CFAD-420D-9C38-CAB1CCAA9AE1}"/>
                  </a:ext>
                </a:extLst>
              </p:cNvPr>
              <p:cNvSpPr txBox="1"/>
              <p:nvPr/>
            </p:nvSpPr>
            <p:spPr>
              <a:xfrm>
                <a:off x="6905738" y="593499"/>
                <a:ext cx="17215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NC         sh-lincSCRG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+ov-SKP2 +in-miR26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2" name="直接连接符 141">
                <a:extLst>
                  <a:ext uri="{FF2B5EF4-FFF2-40B4-BE49-F238E27FC236}">
                    <a16:creationId xmlns:a16="http://schemas.microsoft.com/office/drawing/2014/main" id="{8628BFCB-C506-49D9-8491-5B3F328E5F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93044" y="751328"/>
                <a:ext cx="111544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83" name="文本框 82">
            <a:extLst>
              <a:ext uri="{FF2B5EF4-FFF2-40B4-BE49-F238E27FC236}">
                <a16:creationId xmlns:a16="http://schemas.microsoft.com/office/drawing/2014/main" id="{7B7F1ACA-56DA-4A61-8F0F-8F5046865EA2}"/>
              </a:ext>
            </a:extLst>
          </p:cNvPr>
          <p:cNvSpPr txBox="1"/>
          <p:nvPr/>
        </p:nvSpPr>
        <p:spPr>
          <a:xfrm>
            <a:off x="54065" y="30219"/>
            <a:ext cx="12394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S2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51621126-FF29-47B2-9F2A-D96FD9F11736}"/>
              </a:ext>
            </a:extLst>
          </p:cNvPr>
          <p:cNvSpPr txBox="1"/>
          <p:nvPr/>
        </p:nvSpPr>
        <p:spPr>
          <a:xfrm>
            <a:off x="54065" y="5270812"/>
            <a:ext cx="1213793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 Different proteins expression in HCC cells.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h-lincSCRG1 could down-regulate pro-proliferation related proteins (cyclin D1, CDK4/6) and ETM related proteins (MMPs, N-cadherin </a:t>
            </a:r>
            <a:r>
              <a:rPr lang="en-US" altLang="zh-CN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 Vimentin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), and up-regulate </a:t>
            </a:r>
            <a:r>
              <a:rPr lang="en-US" altLang="zh-CN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-cadherin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, which could 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be </a:t>
            </a:r>
            <a:r>
              <a:rPr lang="en-US" altLang="zh-CN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eversed by co-transfection </a:t>
            </a:r>
            <a:r>
              <a:rPr lang="en-US" altLang="zh-CN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with ov-SKP2 and in-miR26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SNU-387 and Hep3B cell line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5612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</TotalTime>
  <Words>285</Words>
  <Application>Microsoft Office PowerPoint</Application>
  <PresentationFormat>宽屏</PresentationFormat>
  <Paragraphs>15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ou cui</dc:creator>
  <cp:lastModifiedBy>zhou cui</cp:lastModifiedBy>
  <cp:revision>58</cp:revision>
  <dcterms:created xsi:type="dcterms:W3CDTF">2020-10-07T08:37:10Z</dcterms:created>
  <dcterms:modified xsi:type="dcterms:W3CDTF">2020-10-08T03:28:53Z</dcterms:modified>
</cp:coreProperties>
</file>